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74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A93977-47B6-4CB6-90FC-8EEE8F77EAE7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26CB5D-3C34-4C96-9E73-6F5A9A5E14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6214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F9CBF7-6645-4513-B046-FF022E3AD93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0738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8807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588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835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7428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379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119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8741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11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226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741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048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CFAA8-3C78-495F-867C-B76B8D3538EF}" type="datetimeFigureOut">
              <a:rPr lang="zh-CN" altLang="en-US" smtClean="0"/>
              <a:t>2016-12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20428-EF29-4E29-9458-C3C921382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338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9225" y="251521"/>
            <a:ext cx="14076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3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8207" y="753282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5032" y="2777339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组合 11"/>
          <p:cNvGrpSpPr/>
          <p:nvPr/>
        </p:nvGrpSpPr>
        <p:grpSpPr>
          <a:xfrm>
            <a:off x="496648" y="971605"/>
            <a:ext cx="3076368" cy="1517478"/>
            <a:chOff x="178180" y="6664844"/>
            <a:chExt cx="2859630" cy="1436365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340" y="6671664"/>
              <a:ext cx="1273359" cy="12741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78" t="21517" b="31570"/>
            <a:stretch/>
          </p:blipFill>
          <p:spPr bwMode="auto">
            <a:xfrm>
              <a:off x="1692566" y="6664844"/>
              <a:ext cx="1290669" cy="12698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8" name="直接箭头连接符 14"/>
            <p:cNvCxnSpPr/>
            <p:nvPr/>
          </p:nvCxnSpPr>
          <p:spPr>
            <a:xfrm>
              <a:off x="284188" y="8008035"/>
              <a:ext cx="284382" cy="202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15"/>
            <p:cNvCxnSpPr/>
            <p:nvPr/>
          </p:nvCxnSpPr>
          <p:spPr>
            <a:xfrm flipH="1" flipV="1">
              <a:off x="282172" y="7696533"/>
              <a:ext cx="1348" cy="31140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541858" y="7897281"/>
              <a:ext cx="589315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CD8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33726" y="7322693"/>
              <a:ext cx="624077" cy="200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IFN</a:t>
              </a:r>
              <a:r>
                <a:rPr lang="en-US" altLang="zh-CN" sz="800" b="1" dirty="0">
                  <a:latin typeface="Arial" pitchFamily="34" charset="0"/>
                  <a:cs typeface="Arial" pitchFamily="34" charset="0"/>
                  <a:sym typeface="Symbol" panose="05050102010706020507" pitchFamily="18" charset="2"/>
                </a:rPr>
                <a:t>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箭头连接符 18"/>
            <p:cNvCxnSpPr/>
            <p:nvPr/>
          </p:nvCxnSpPr>
          <p:spPr>
            <a:xfrm>
              <a:off x="1654259" y="8003585"/>
              <a:ext cx="284382" cy="202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箭头连接符 19"/>
            <p:cNvCxnSpPr/>
            <p:nvPr/>
          </p:nvCxnSpPr>
          <p:spPr>
            <a:xfrm flipH="1" flipV="1">
              <a:off x="1652242" y="7692083"/>
              <a:ext cx="1348" cy="31140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911890" y="7891631"/>
              <a:ext cx="589315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CD2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1289852" y="7199191"/>
              <a:ext cx="735718" cy="200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CD28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35467" y="6693148"/>
              <a:ext cx="402343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9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箭头连接符 23"/>
            <p:cNvCxnSpPr/>
            <p:nvPr/>
          </p:nvCxnSpPr>
          <p:spPr>
            <a:xfrm>
              <a:off x="1508266" y="6855805"/>
              <a:ext cx="20534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635467" y="7681437"/>
              <a:ext cx="402343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  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21864" y="7675777"/>
              <a:ext cx="509395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  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627932" y="6689502"/>
              <a:ext cx="503327" cy="2039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>  0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27629" y="3045236"/>
            <a:ext cx="3893459" cy="3587300"/>
            <a:chOff x="930450" y="357798"/>
            <a:chExt cx="4093106" cy="3665562"/>
          </a:xfrm>
        </p:grpSpPr>
        <p:grpSp>
          <p:nvGrpSpPr>
            <p:cNvPr id="22" name="组合 35"/>
            <p:cNvGrpSpPr/>
            <p:nvPr/>
          </p:nvGrpSpPr>
          <p:grpSpPr>
            <a:xfrm>
              <a:off x="1308887" y="809495"/>
              <a:ext cx="3584758" cy="3213865"/>
              <a:chOff x="3213090" y="2428868"/>
              <a:chExt cx="3859240" cy="3859240"/>
            </a:xfrm>
          </p:grpSpPr>
          <p:pic>
            <p:nvPicPr>
              <p:cNvPr id="32" name="Picture 7" descr="F:\临床实验结果汇总\ELISPOT 原始数据\061 代表图\061 w16 env w.pn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500563" y="3740636"/>
                <a:ext cx="1260000" cy="1260000"/>
              </a:xfrm>
              <a:prstGeom prst="rect">
                <a:avLst/>
              </a:prstGeom>
              <a:noFill/>
            </p:spPr>
          </p:pic>
          <p:pic>
            <p:nvPicPr>
              <p:cNvPr id="33" name="Picture 8" descr="F:\临床实验结果汇总\ELISPOT 原始数据\061 代表图\061 W16 w-o w.pn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5786447" y="3740636"/>
                <a:ext cx="1260000" cy="1260000"/>
              </a:xfrm>
              <a:prstGeom prst="rect">
                <a:avLst/>
              </a:prstGeom>
              <a:noFill/>
            </p:spPr>
          </p:pic>
          <p:pic>
            <p:nvPicPr>
              <p:cNvPr id="34" name="Picture 10" descr="F:\临床实验结果汇总\ELISPOT 原始数据\061 代表图\061 代表图\061 W31 env w.pn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4505313" y="5000636"/>
                <a:ext cx="1260000" cy="1260000"/>
              </a:xfrm>
              <a:prstGeom prst="rect">
                <a:avLst/>
              </a:prstGeom>
              <a:noFill/>
            </p:spPr>
          </p:pic>
          <p:pic>
            <p:nvPicPr>
              <p:cNvPr id="35" name="Picture 11" descr="F:\临床实验结果汇总\ELISPOT 原始数据\061 代表图\061 代表图\061 W31 w-o w.png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5786451" y="5000636"/>
                <a:ext cx="1259999" cy="1260000"/>
              </a:xfrm>
              <a:prstGeom prst="rect">
                <a:avLst/>
              </a:prstGeom>
              <a:noFill/>
            </p:spPr>
          </p:pic>
          <p:pic>
            <p:nvPicPr>
              <p:cNvPr id="36" name="Picture 14" descr="F:\临床实验结果汇总\ELISPOT 原始数据\061 代表图\061 代表图\061 w31 pep w.png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214683" y="5000636"/>
                <a:ext cx="1260671" cy="1260000"/>
              </a:xfrm>
              <a:prstGeom prst="rect">
                <a:avLst/>
              </a:prstGeom>
              <a:noFill/>
            </p:spPr>
          </p:pic>
          <p:pic>
            <p:nvPicPr>
              <p:cNvPr id="37" name="Picture 15" descr="F:\临床实验结果汇总\ELISPOT 原始数据\061 代表图\061 代表图\061 w16 pep w.pn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3214679" y="3740636"/>
                <a:ext cx="1260000" cy="1260000"/>
              </a:xfrm>
              <a:prstGeom prst="rect">
                <a:avLst/>
              </a:prstGeom>
              <a:noFill/>
            </p:spPr>
          </p:pic>
          <p:pic>
            <p:nvPicPr>
              <p:cNvPr id="38" name="Picture 1" descr="I:\061 w1\061 W1 pep_1.png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3214679" y="2454752"/>
                <a:ext cx="1259999" cy="1260000"/>
              </a:xfrm>
              <a:prstGeom prst="rect">
                <a:avLst/>
              </a:prstGeom>
              <a:noFill/>
            </p:spPr>
          </p:pic>
          <p:pic>
            <p:nvPicPr>
              <p:cNvPr id="39" name="Picture 2" descr="I:\061 w1\061 W1 env.png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4500562" y="2454752"/>
                <a:ext cx="1253363" cy="1260000"/>
              </a:xfrm>
              <a:prstGeom prst="rect">
                <a:avLst/>
              </a:prstGeom>
              <a:noFill/>
            </p:spPr>
          </p:pic>
          <p:pic>
            <p:nvPicPr>
              <p:cNvPr id="40" name="Picture 3" descr="I:\061 w1\061 W1 w_o_1.png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5786447" y="2454752"/>
                <a:ext cx="1260000" cy="1260000"/>
              </a:xfrm>
              <a:prstGeom prst="rect">
                <a:avLst/>
              </a:prstGeom>
              <a:noFill/>
            </p:spPr>
          </p:pic>
          <p:cxnSp>
            <p:nvCxnSpPr>
              <p:cNvPr id="41" name="直接连接符 18"/>
              <p:cNvCxnSpPr/>
              <p:nvPr/>
            </p:nvCxnSpPr>
            <p:spPr>
              <a:xfrm>
                <a:off x="3214678" y="2428868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19"/>
              <p:cNvCxnSpPr/>
              <p:nvPr/>
            </p:nvCxnSpPr>
            <p:spPr>
              <a:xfrm rot="5400000">
                <a:off x="5142709" y="4357694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20"/>
              <p:cNvCxnSpPr/>
              <p:nvPr/>
            </p:nvCxnSpPr>
            <p:spPr>
              <a:xfrm rot="5400000">
                <a:off x="1285058" y="4357694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21"/>
              <p:cNvCxnSpPr/>
              <p:nvPr/>
            </p:nvCxnSpPr>
            <p:spPr>
              <a:xfrm>
                <a:off x="3214678" y="6286520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22"/>
              <p:cNvCxnSpPr/>
              <p:nvPr/>
            </p:nvCxnSpPr>
            <p:spPr>
              <a:xfrm>
                <a:off x="3214677" y="3714752"/>
                <a:ext cx="3857653" cy="15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23"/>
              <p:cNvCxnSpPr/>
              <p:nvPr/>
            </p:nvCxnSpPr>
            <p:spPr>
              <a:xfrm>
                <a:off x="3214678" y="5000636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24"/>
              <p:cNvCxnSpPr/>
              <p:nvPr/>
            </p:nvCxnSpPr>
            <p:spPr>
              <a:xfrm rot="5400000">
                <a:off x="2572530" y="4356900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25"/>
              <p:cNvCxnSpPr/>
              <p:nvPr/>
            </p:nvCxnSpPr>
            <p:spPr>
              <a:xfrm rot="5400000">
                <a:off x="3856825" y="4357694"/>
                <a:ext cx="3857652" cy="158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Box 78"/>
            <p:cNvSpPr txBox="1"/>
            <p:nvPr/>
          </p:nvSpPr>
          <p:spPr>
            <a:xfrm>
              <a:off x="1356405" y="466676"/>
              <a:ext cx="1169483" cy="252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Peptides pool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79"/>
            <p:cNvSpPr txBox="1"/>
            <p:nvPr/>
          </p:nvSpPr>
          <p:spPr>
            <a:xfrm>
              <a:off x="2657329" y="357798"/>
              <a:ext cx="966268" cy="41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Irrelevant peptide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80"/>
            <p:cNvSpPr txBox="1"/>
            <p:nvPr/>
          </p:nvSpPr>
          <p:spPr>
            <a:xfrm>
              <a:off x="3580496" y="480787"/>
              <a:ext cx="1443060" cy="252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Without peptide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81"/>
            <p:cNvSpPr txBox="1"/>
            <p:nvPr/>
          </p:nvSpPr>
          <p:spPr>
            <a:xfrm rot="10800000">
              <a:off x="957073" y="780884"/>
              <a:ext cx="355914" cy="102875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Baseline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82"/>
            <p:cNvSpPr txBox="1"/>
            <p:nvPr/>
          </p:nvSpPr>
          <p:spPr>
            <a:xfrm rot="10800000">
              <a:off x="940661" y="1961444"/>
              <a:ext cx="355914" cy="797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16 weeks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83"/>
            <p:cNvSpPr txBox="1"/>
            <p:nvPr/>
          </p:nvSpPr>
          <p:spPr>
            <a:xfrm rot="10800000">
              <a:off x="930450" y="3056061"/>
              <a:ext cx="355914" cy="8328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itchFamily="34" charset="0"/>
                  <a:cs typeface="Arial" pitchFamily="34" charset="0"/>
                </a:rPr>
                <a:t>31 weeks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45740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全屏显示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THY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韩研妍</dc:creator>
  <cp:lastModifiedBy>韩研妍</cp:lastModifiedBy>
  <cp:revision>1</cp:revision>
  <dcterms:created xsi:type="dcterms:W3CDTF">2016-12-08T03:24:50Z</dcterms:created>
  <dcterms:modified xsi:type="dcterms:W3CDTF">2016-12-08T03:25:09Z</dcterms:modified>
</cp:coreProperties>
</file>